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A06A39-C1FB-9CBC-BF43-2E6B21A574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C8A399-AB5A-DE8D-0A78-29E49B0EE4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022A01-C400-8B85-3046-5F0044DD3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D4AB9A-824E-0A14-F54E-1F5B0D9A42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148927-9A4C-842A-EEFB-0868DF190A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142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18ED7B-F196-C8E1-A190-F5AD1405CF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27B945-0921-832F-512F-5FE52C9196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C2F563-F9A2-40C7-57B0-9A54230C83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8B899A-E017-0C07-9941-8C215DBD92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E36763-5444-5D54-F515-45FFE82E9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117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A318DCD-710B-212A-6350-15ECF2180D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FE119C-4BC7-9E2B-9E90-648C4A3D12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7D8912-626C-90E7-C082-A4390F155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2E966D-17CE-CCDC-7EE3-DB7A9028C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6F18C0-AD11-0408-2DAB-03EB4F6DEF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426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52A8DC-37B5-E91E-4054-5B9F2EDEED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EAEE1B-618F-340F-BEB6-70DE5C5779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4688AA-7BF2-FB1F-8D7C-F26AF213B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E46CAE-354E-B247-9AA4-FB682350D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C9C060-9511-E72C-DAF9-A745B9B491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588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A21634-1C7B-405A-8078-CC1A09900F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F9E96F-4D76-2DF4-8D2E-0747557143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3FC0DF-FE50-84BC-7A93-4524D36A7F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97CBEE-6E99-C19F-CC21-F6A315B31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E3B53D-4D55-1BAD-A6D3-EF2B26BEC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665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B6BC9-D749-DC50-8D95-0AD13A8F3E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CE7CB0-0F37-A487-C8D7-7E9A4978D0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9E2810-7B26-97FC-2A5F-1CC108AC7F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5C510D-BE87-0091-95D5-C0A5CC13F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7E0375-6F8E-4646-7516-2AD8FB953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BB0638-874F-0BF6-F87E-F05460126F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909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E0D830-2BD3-E7CB-3C30-8399527B6F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1A883D-6645-DD3E-7FF6-DACEBBBA71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95D8E5-50C2-E48C-0953-91F5FA7A34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2741C15-8F94-7760-7342-742FF4EAB0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380D90-983C-3AAD-1744-42CACD9C2C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7EFF1B1-EDFF-BBDA-76E1-04D459FB0E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8E29D9F-D3E6-C738-B502-68D8687AC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B151A7-9A4F-E722-047D-9C55D10C4D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121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5146AD-CDC3-C701-D26E-A958F0241E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DD1AD5A-5748-3CCD-5B17-0A4E2FE660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59C79E1-5525-2E76-90B9-A1F981106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F156D74-F704-A397-E016-20CF5FC00B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300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C3CD4B-3B42-55AD-F5C0-713E5D898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DD4D06B-B881-5B4B-9767-C32398B0F8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19E679E-FB24-9D7D-9D32-23CD835F0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1459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DE500C-D3A5-1D38-8C24-DE94ECBDF6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1AE458-F277-D15D-8879-306DE6DF3C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E3591B-D1A9-0801-8397-A33E7CA404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323EC4-7CA4-3AE6-42B4-993210A64D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B04482-2F20-41D1-B276-53893EED0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B2A5A2-1FD0-DB03-5D31-728D490BB4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89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CF5338-F661-62A9-F96A-279B5D295E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6C63D7F-9EB0-C4FC-B307-E90149CD0D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8D29F1-F9C7-B660-8DA5-9100CED23B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8A4F1E-E5E3-59AE-1A06-FB67388025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8C6AE0-312E-8E03-FFFF-78315D1E2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B3D517-3AB4-81C9-E02B-406E9D27E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892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6D24B3F-6BC4-ED64-0734-25B8B4484D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F04E2E-A6A1-785E-D249-075B5E78BC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957B2E-59AE-ABFF-7C7B-B6B1F8D6B0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AEC26D-A914-A7D2-6DBA-AEFAFE78A3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C7B47E-38C8-3B00-6ECC-A72D2C956F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650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E2AF283-BAFD-CC24-138C-F6244C0BCD6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98D4896A-51D0-6914-9ED0-0C3A8493A798}"/>
              </a:ext>
            </a:extLst>
          </p:cNvPr>
          <p:cNvGrpSpPr/>
          <p:nvPr/>
        </p:nvGrpSpPr>
        <p:grpSpPr>
          <a:xfrm>
            <a:off x="2385646" y="0"/>
            <a:ext cx="7420708" cy="6858001"/>
            <a:chOff x="2168769" y="-1"/>
            <a:chExt cx="7420708" cy="6858001"/>
          </a:xfrm>
        </p:grpSpPr>
        <p:pic>
          <p:nvPicPr>
            <p:cNvPr id="2" name="Picture 1" descr="A graph of a number of dots&#10;&#10;AI-generated content may be incorrect.">
              <a:extLst>
                <a:ext uri="{FF2B5EF4-FFF2-40B4-BE49-F238E27FC236}">
                  <a16:creationId xmlns:a16="http://schemas.microsoft.com/office/drawing/2014/main" id="{5ECC922B-0AE8-B054-1ECA-3E0857B01E8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68769" y="-1"/>
              <a:ext cx="4220308" cy="685800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6435F69-CFC1-B9E8-7D95-ABD8970CE79C}"/>
                </a:ext>
              </a:extLst>
            </p:cNvPr>
            <p:cNvSpPr txBox="1"/>
            <p:nvPr/>
          </p:nvSpPr>
          <p:spPr>
            <a:xfrm>
              <a:off x="6389077" y="1028342"/>
              <a:ext cx="3200400" cy="480131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 rtl="0">
                <a:spcAft>
                  <a:spcPts val="800"/>
                </a:spcAft>
                <a:buNone/>
              </a:pPr>
              <a:r>
                <a:rPr lang="en-US" sz="1800" b="1" i="0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upplementary figure 4: Gene ontology enrichment analysis</a:t>
              </a:r>
              <a:r>
                <a:rPr lang="en-US" sz="1800" b="0" i="0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. Comparison of GO terms enriched within full and significant gene lists derived from both HBCC (left) and NABEC (right) analyses. Terms were ranked according to their ratio (intersection / term size) with the number of reduced child terms displayed in brackets (term reduction </a:t>
              </a:r>
              <a:r>
                <a:rPr lang="en-US" sz="1800" b="0" i="0" u="none" strike="noStrike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utilised</a:t>
              </a:r>
              <a:r>
                <a:rPr lang="en-US" sz="1800" b="0" i="0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 a hierarchical tree cut-off threshold of 0.9). Dot size corresponds to the ratio of the child term with the least significant p-value.</a:t>
              </a:r>
              <a:endParaRPr lang="en-US" b="0" dirty="0">
                <a:effectLst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6968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85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rant, Spencer (NIH/NIA/IRP) [F]</dc:creator>
  <cp:lastModifiedBy>Grant, Spencer (NIH/NIA/IRP) [F]</cp:lastModifiedBy>
  <cp:revision>4</cp:revision>
  <dcterms:created xsi:type="dcterms:W3CDTF">2025-09-30T17:05:41Z</dcterms:created>
  <dcterms:modified xsi:type="dcterms:W3CDTF">2025-09-30T18:41:20Z</dcterms:modified>
</cp:coreProperties>
</file>